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1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C021-2622-4FCE-907E-B8E762BF236B}" type="datetimeFigureOut">
              <a:rPr lang="it-IT" smtClean="0"/>
              <a:t>06/0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E41D7-B172-444D-B522-33B22961AB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3922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C021-2622-4FCE-907E-B8E762BF236B}" type="datetimeFigureOut">
              <a:rPr lang="it-IT" smtClean="0"/>
              <a:t>06/0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E41D7-B172-444D-B522-33B22961AB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75200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C021-2622-4FCE-907E-B8E762BF236B}" type="datetimeFigureOut">
              <a:rPr lang="it-IT" smtClean="0"/>
              <a:t>06/0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E41D7-B172-444D-B522-33B22961AB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0746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C021-2622-4FCE-907E-B8E762BF236B}" type="datetimeFigureOut">
              <a:rPr lang="it-IT" smtClean="0"/>
              <a:t>06/0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E41D7-B172-444D-B522-33B22961AB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1872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C021-2622-4FCE-907E-B8E762BF236B}" type="datetimeFigureOut">
              <a:rPr lang="it-IT" smtClean="0"/>
              <a:t>06/0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E41D7-B172-444D-B522-33B22961AB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75040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C021-2622-4FCE-907E-B8E762BF236B}" type="datetimeFigureOut">
              <a:rPr lang="it-IT" smtClean="0"/>
              <a:t>06/01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E41D7-B172-444D-B522-33B22961AB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77793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C021-2622-4FCE-907E-B8E762BF236B}" type="datetimeFigureOut">
              <a:rPr lang="it-IT" smtClean="0"/>
              <a:t>06/01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E41D7-B172-444D-B522-33B22961AB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05455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C021-2622-4FCE-907E-B8E762BF236B}" type="datetimeFigureOut">
              <a:rPr lang="it-IT" smtClean="0"/>
              <a:t>06/01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E41D7-B172-444D-B522-33B22961AB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26960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C021-2622-4FCE-907E-B8E762BF236B}" type="datetimeFigureOut">
              <a:rPr lang="it-IT" smtClean="0"/>
              <a:t>06/01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E41D7-B172-444D-B522-33B22961AB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8396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C021-2622-4FCE-907E-B8E762BF236B}" type="datetimeFigureOut">
              <a:rPr lang="it-IT" smtClean="0"/>
              <a:t>06/01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E41D7-B172-444D-B522-33B22961AB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7984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C021-2622-4FCE-907E-B8E762BF236B}" type="datetimeFigureOut">
              <a:rPr lang="it-IT" smtClean="0"/>
              <a:t>06/01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E41D7-B172-444D-B522-33B22961AB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4221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5C021-2622-4FCE-907E-B8E762BF236B}" type="datetimeFigureOut">
              <a:rPr lang="it-IT" smtClean="0"/>
              <a:t>06/0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EE41D7-B172-444D-B522-33B22961AB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1379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/>
          <p:cNvSpPr txBox="1"/>
          <p:nvPr/>
        </p:nvSpPr>
        <p:spPr>
          <a:xfrm>
            <a:off x="3332293" y="1273702"/>
            <a:ext cx="6665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/>
              <a:t>1.0</a:t>
            </a:r>
          </a:p>
        </p:txBody>
      </p:sp>
      <p:sp>
        <p:nvSpPr>
          <p:cNvPr id="8" name="CasellaDiTesto 7"/>
          <p:cNvSpPr txBox="1"/>
          <p:nvPr/>
        </p:nvSpPr>
        <p:spPr>
          <a:xfrm>
            <a:off x="3332293" y="1997057"/>
            <a:ext cx="6665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/>
              <a:t>0.8</a:t>
            </a:r>
          </a:p>
        </p:txBody>
      </p:sp>
      <p:sp>
        <p:nvSpPr>
          <p:cNvPr id="9" name="CasellaDiTesto 8"/>
          <p:cNvSpPr txBox="1"/>
          <p:nvPr/>
        </p:nvSpPr>
        <p:spPr>
          <a:xfrm>
            <a:off x="3332293" y="2710252"/>
            <a:ext cx="6665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/>
              <a:t>0.6</a:t>
            </a:r>
          </a:p>
        </p:txBody>
      </p:sp>
      <p:sp>
        <p:nvSpPr>
          <p:cNvPr id="10" name="CasellaDiTesto 9"/>
          <p:cNvSpPr txBox="1"/>
          <p:nvPr/>
        </p:nvSpPr>
        <p:spPr>
          <a:xfrm>
            <a:off x="3332293" y="3405217"/>
            <a:ext cx="6665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/>
              <a:t>0.4</a:t>
            </a:r>
          </a:p>
        </p:txBody>
      </p:sp>
      <p:sp>
        <p:nvSpPr>
          <p:cNvPr id="11" name="CasellaDiTesto 10"/>
          <p:cNvSpPr txBox="1"/>
          <p:nvPr/>
        </p:nvSpPr>
        <p:spPr>
          <a:xfrm>
            <a:off x="3332293" y="4108252"/>
            <a:ext cx="6665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/>
              <a:t>0.2</a:t>
            </a:r>
          </a:p>
        </p:txBody>
      </p:sp>
      <p:sp>
        <p:nvSpPr>
          <p:cNvPr id="12" name="CasellaDiTesto 11"/>
          <p:cNvSpPr txBox="1"/>
          <p:nvPr/>
        </p:nvSpPr>
        <p:spPr>
          <a:xfrm>
            <a:off x="3332293" y="4764191"/>
            <a:ext cx="6665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/>
              <a:t>0.0</a:t>
            </a:r>
          </a:p>
        </p:txBody>
      </p:sp>
      <p:sp>
        <p:nvSpPr>
          <p:cNvPr id="13" name="CasellaDiTesto 12"/>
          <p:cNvSpPr txBox="1"/>
          <p:nvPr/>
        </p:nvSpPr>
        <p:spPr>
          <a:xfrm rot="16200000">
            <a:off x="2223492" y="2794933"/>
            <a:ext cx="20594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Cumulative </a:t>
            </a:r>
            <a:r>
              <a:rPr lang="it-IT" b="1" dirty="0" err="1"/>
              <a:t>survival</a:t>
            </a:r>
            <a:endParaRPr lang="it-IT" b="1" dirty="0"/>
          </a:p>
        </p:txBody>
      </p:sp>
      <p:sp>
        <p:nvSpPr>
          <p:cNvPr id="15" name="CasellaDiTesto 14"/>
          <p:cNvSpPr txBox="1"/>
          <p:nvPr/>
        </p:nvSpPr>
        <p:spPr>
          <a:xfrm>
            <a:off x="3967717" y="3811942"/>
            <a:ext cx="7633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/>
              <a:t>P=0.61</a:t>
            </a:r>
          </a:p>
        </p:txBody>
      </p:sp>
      <p:cxnSp>
        <p:nvCxnSpPr>
          <p:cNvPr id="17" name="Connettore 1 16"/>
          <p:cNvCxnSpPr/>
          <p:nvPr/>
        </p:nvCxnSpPr>
        <p:spPr>
          <a:xfrm>
            <a:off x="5912597" y="1623041"/>
            <a:ext cx="360000" cy="0"/>
          </a:xfrm>
          <a:prstGeom prst="line">
            <a:avLst/>
          </a:prstGeom>
          <a:noFill/>
          <a:ln w="28575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cxnSp>
      <p:cxnSp>
        <p:nvCxnSpPr>
          <p:cNvPr id="19" name="Connettore 1 18"/>
          <p:cNvCxnSpPr/>
          <p:nvPr/>
        </p:nvCxnSpPr>
        <p:spPr>
          <a:xfrm>
            <a:off x="5912597" y="1827153"/>
            <a:ext cx="360000" cy="0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asellaDiTesto 19"/>
          <p:cNvSpPr txBox="1"/>
          <p:nvPr/>
        </p:nvSpPr>
        <p:spPr>
          <a:xfrm>
            <a:off x="6288611" y="1469218"/>
            <a:ext cx="1016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On Vitamin D</a:t>
            </a:r>
          </a:p>
        </p:txBody>
      </p:sp>
      <p:sp>
        <p:nvSpPr>
          <p:cNvPr id="21" name="CasellaDiTesto 20"/>
          <p:cNvSpPr txBox="1"/>
          <p:nvPr/>
        </p:nvSpPr>
        <p:spPr>
          <a:xfrm>
            <a:off x="6295731" y="1672894"/>
            <a:ext cx="8209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/>
              <a:t>Untreated</a:t>
            </a:r>
            <a:endParaRPr lang="it-IT" sz="1200" dirty="0"/>
          </a:p>
        </p:txBody>
      </p:sp>
      <p:sp>
        <p:nvSpPr>
          <p:cNvPr id="5" name="CasellaDiTesto 4"/>
          <p:cNvSpPr txBox="1"/>
          <p:nvPr/>
        </p:nvSpPr>
        <p:spPr>
          <a:xfrm>
            <a:off x="3968386" y="4983778"/>
            <a:ext cx="43501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0            10           20            30           40           50           60</a:t>
            </a:r>
          </a:p>
        </p:txBody>
      </p:sp>
      <p:sp>
        <p:nvSpPr>
          <p:cNvPr id="14" name="CasellaDiTesto 13"/>
          <p:cNvSpPr txBox="1"/>
          <p:nvPr/>
        </p:nvSpPr>
        <p:spPr>
          <a:xfrm>
            <a:off x="5314444" y="5219163"/>
            <a:ext cx="12866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Time (</a:t>
            </a:r>
            <a:r>
              <a:rPr lang="it-IT" b="1" dirty="0" err="1"/>
              <a:t>days</a:t>
            </a:r>
            <a:r>
              <a:rPr lang="it-IT" b="1" dirty="0"/>
              <a:t>)</a:t>
            </a:r>
          </a:p>
        </p:txBody>
      </p:sp>
      <p:sp>
        <p:nvSpPr>
          <p:cNvPr id="26" name="Line 8"/>
          <p:cNvSpPr>
            <a:spLocks noChangeShapeType="1"/>
          </p:cNvSpPr>
          <p:nvPr/>
        </p:nvSpPr>
        <p:spPr bwMode="auto">
          <a:xfrm>
            <a:off x="4108768" y="4932998"/>
            <a:ext cx="0" cy="635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7" name="Line 9"/>
          <p:cNvSpPr>
            <a:spLocks noChangeShapeType="1"/>
          </p:cNvSpPr>
          <p:nvPr/>
        </p:nvSpPr>
        <p:spPr bwMode="auto">
          <a:xfrm>
            <a:off x="4731068" y="4932998"/>
            <a:ext cx="0" cy="635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8" name="Line 10"/>
          <p:cNvSpPr>
            <a:spLocks noChangeShapeType="1"/>
          </p:cNvSpPr>
          <p:nvPr/>
        </p:nvSpPr>
        <p:spPr bwMode="auto">
          <a:xfrm>
            <a:off x="5354955" y="4932998"/>
            <a:ext cx="0" cy="635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9" name="Line 11"/>
          <p:cNvSpPr>
            <a:spLocks noChangeShapeType="1"/>
          </p:cNvSpPr>
          <p:nvPr/>
        </p:nvSpPr>
        <p:spPr bwMode="auto">
          <a:xfrm>
            <a:off x="5977255" y="4932998"/>
            <a:ext cx="0" cy="635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0" name="Line 12"/>
          <p:cNvSpPr>
            <a:spLocks noChangeShapeType="1"/>
          </p:cNvSpPr>
          <p:nvPr/>
        </p:nvSpPr>
        <p:spPr bwMode="auto">
          <a:xfrm>
            <a:off x="6601143" y="4932998"/>
            <a:ext cx="0" cy="635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1" name="Line 13"/>
          <p:cNvSpPr>
            <a:spLocks noChangeShapeType="1"/>
          </p:cNvSpPr>
          <p:nvPr/>
        </p:nvSpPr>
        <p:spPr bwMode="auto">
          <a:xfrm>
            <a:off x="7223443" y="4932998"/>
            <a:ext cx="0" cy="635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2" name="Line 14"/>
          <p:cNvSpPr>
            <a:spLocks noChangeShapeType="1"/>
          </p:cNvSpPr>
          <p:nvPr/>
        </p:nvSpPr>
        <p:spPr bwMode="auto">
          <a:xfrm>
            <a:off x="7847330" y="4932998"/>
            <a:ext cx="0" cy="635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42" name="Line 24"/>
          <p:cNvSpPr>
            <a:spLocks noChangeShapeType="1"/>
          </p:cNvSpPr>
          <p:nvPr/>
        </p:nvSpPr>
        <p:spPr bwMode="auto">
          <a:xfrm flipH="1">
            <a:off x="3848418" y="4930775"/>
            <a:ext cx="52388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43" name="Line 25"/>
          <p:cNvSpPr>
            <a:spLocks noChangeShapeType="1"/>
          </p:cNvSpPr>
          <p:nvPr/>
        </p:nvSpPr>
        <p:spPr bwMode="auto">
          <a:xfrm flipH="1">
            <a:off x="3848418" y="4227513"/>
            <a:ext cx="52388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44" name="Line 26"/>
          <p:cNvSpPr>
            <a:spLocks noChangeShapeType="1"/>
          </p:cNvSpPr>
          <p:nvPr/>
        </p:nvSpPr>
        <p:spPr bwMode="auto">
          <a:xfrm flipH="1">
            <a:off x="3848418" y="3525838"/>
            <a:ext cx="52388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45" name="Line 27"/>
          <p:cNvSpPr>
            <a:spLocks noChangeShapeType="1"/>
          </p:cNvSpPr>
          <p:nvPr/>
        </p:nvSpPr>
        <p:spPr bwMode="auto">
          <a:xfrm flipH="1">
            <a:off x="3848418" y="2824163"/>
            <a:ext cx="52388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46" name="Line 28"/>
          <p:cNvSpPr>
            <a:spLocks noChangeShapeType="1"/>
          </p:cNvSpPr>
          <p:nvPr/>
        </p:nvSpPr>
        <p:spPr bwMode="auto">
          <a:xfrm flipH="1">
            <a:off x="3848418" y="2120900"/>
            <a:ext cx="52388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47" name="Line 29"/>
          <p:cNvSpPr>
            <a:spLocks noChangeShapeType="1"/>
          </p:cNvSpPr>
          <p:nvPr/>
        </p:nvSpPr>
        <p:spPr bwMode="auto">
          <a:xfrm flipH="1">
            <a:off x="3848418" y="1417638"/>
            <a:ext cx="52388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55" name="Freeform 37"/>
          <p:cNvSpPr>
            <a:spLocks/>
          </p:cNvSpPr>
          <p:nvPr/>
        </p:nvSpPr>
        <p:spPr bwMode="auto">
          <a:xfrm>
            <a:off x="4108768" y="1417638"/>
            <a:ext cx="3176588" cy="1223963"/>
          </a:xfrm>
          <a:custGeom>
            <a:avLst/>
            <a:gdLst>
              <a:gd name="T0" fmla="*/ 0 w 2001"/>
              <a:gd name="T1" fmla="*/ 0 h 771"/>
              <a:gd name="T2" fmla="*/ 79 w 2001"/>
              <a:gd name="T3" fmla="*/ 0 h 771"/>
              <a:gd name="T4" fmla="*/ 79 w 2001"/>
              <a:gd name="T5" fmla="*/ 81 h 771"/>
              <a:gd name="T6" fmla="*/ 118 w 2001"/>
              <a:gd name="T7" fmla="*/ 81 h 771"/>
              <a:gd name="T8" fmla="*/ 118 w 2001"/>
              <a:gd name="T9" fmla="*/ 121 h 771"/>
              <a:gd name="T10" fmla="*/ 157 w 2001"/>
              <a:gd name="T11" fmla="*/ 121 h 771"/>
              <a:gd name="T12" fmla="*/ 157 w 2001"/>
              <a:gd name="T13" fmla="*/ 164 h 771"/>
              <a:gd name="T14" fmla="*/ 275 w 2001"/>
              <a:gd name="T15" fmla="*/ 164 h 771"/>
              <a:gd name="T16" fmla="*/ 275 w 2001"/>
              <a:gd name="T17" fmla="*/ 310 h 771"/>
              <a:gd name="T18" fmla="*/ 314 w 2001"/>
              <a:gd name="T19" fmla="*/ 310 h 771"/>
              <a:gd name="T20" fmla="*/ 314 w 2001"/>
              <a:gd name="T21" fmla="*/ 364 h 771"/>
              <a:gd name="T22" fmla="*/ 353 w 2001"/>
              <a:gd name="T23" fmla="*/ 364 h 771"/>
              <a:gd name="T24" fmla="*/ 353 w 2001"/>
              <a:gd name="T25" fmla="*/ 426 h 771"/>
              <a:gd name="T26" fmla="*/ 471 w 2001"/>
              <a:gd name="T27" fmla="*/ 426 h 771"/>
              <a:gd name="T28" fmla="*/ 471 w 2001"/>
              <a:gd name="T29" fmla="*/ 511 h 771"/>
              <a:gd name="T30" fmla="*/ 550 w 2001"/>
              <a:gd name="T31" fmla="*/ 511 h 771"/>
              <a:gd name="T32" fmla="*/ 550 w 2001"/>
              <a:gd name="T33" fmla="*/ 611 h 771"/>
              <a:gd name="T34" fmla="*/ 824 w 2001"/>
              <a:gd name="T35" fmla="*/ 611 h 771"/>
              <a:gd name="T36" fmla="*/ 824 w 2001"/>
              <a:gd name="T37" fmla="*/ 771 h 771"/>
              <a:gd name="T38" fmla="*/ 2001 w 2001"/>
              <a:gd name="T39" fmla="*/ 771 h 771"/>
              <a:gd name="T40" fmla="*/ 2001 w 2001"/>
              <a:gd name="T41" fmla="*/ 771 h 7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</a:cxnLst>
            <a:rect l="0" t="0" r="r" b="b"/>
            <a:pathLst>
              <a:path w="2001" h="771">
                <a:moveTo>
                  <a:pt x="0" y="0"/>
                </a:moveTo>
                <a:lnTo>
                  <a:pt x="79" y="0"/>
                </a:lnTo>
                <a:lnTo>
                  <a:pt x="79" y="81"/>
                </a:lnTo>
                <a:lnTo>
                  <a:pt x="118" y="81"/>
                </a:lnTo>
                <a:lnTo>
                  <a:pt x="118" y="121"/>
                </a:lnTo>
                <a:lnTo>
                  <a:pt x="157" y="121"/>
                </a:lnTo>
                <a:lnTo>
                  <a:pt x="157" y="164"/>
                </a:lnTo>
                <a:lnTo>
                  <a:pt x="275" y="164"/>
                </a:lnTo>
                <a:lnTo>
                  <a:pt x="275" y="310"/>
                </a:lnTo>
                <a:lnTo>
                  <a:pt x="314" y="310"/>
                </a:lnTo>
                <a:lnTo>
                  <a:pt x="314" y="364"/>
                </a:lnTo>
                <a:lnTo>
                  <a:pt x="353" y="364"/>
                </a:lnTo>
                <a:lnTo>
                  <a:pt x="353" y="426"/>
                </a:lnTo>
                <a:lnTo>
                  <a:pt x="471" y="426"/>
                </a:lnTo>
                <a:lnTo>
                  <a:pt x="471" y="511"/>
                </a:lnTo>
                <a:lnTo>
                  <a:pt x="550" y="511"/>
                </a:lnTo>
                <a:lnTo>
                  <a:pt x="550" y="611"/>
                </a:lnTo>
                <a:lnTo>
                  <a:pt x="824" y="611"/>
                </a:lnTo>
                <a:lnTo>
                  <a:pt x="824" y="771"/>
                </a:lnTo>
                <a:lnTo>
                  <a:pt x="2001" y="771"/>
                </a:lnTo>
                <a:lnTo>
                  <a:pt x="2001" y="771"/>
                </a:lnTo>
              </a:path>
            </a:pathLst>
          </a:custGeom>
          <a:ln w="12700">
            <a:solidFill>
              <a:schemeClr val="tx1">
                <a:lumMod val="95000"/>
                <a:lumOff val="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56" name="Freeform 38"/>
          <p:cNvSpPr>
            <a:spLocks/>
          </p:cNvSpPr>
          <p:nvPr/>
        </p:nvSpPr>
        <p:spPr bwMode="auto">
          <a:xfrm>
            <a:off x="4108768" y="1417638"/>
            <a:ext cx="2989263" cy="1514475"/>
          </a:xfrm>
          <a:custGeom>
            <a:avLst/>
            <a:gdLst>
              <a:gd name="T0" fmla="*/ 0 w 1883"/>
              <a:gd name="T1" fmla="*/ 0 h 954"/>
              <a:gd name="T2" fmla="*/ 79 w 1883"/>
              <a:gd name="T3" fmla="*/ 0 h 954"/>
              <a:gd name="T4" fmla="*/ 79 w 1883"/>
              <a:gd name="T5" fmla="*/ 0 h 954"/>
              <a:gd name="T6" fmla="*/ 196 w 1883"/>
              <a:gd name="T7" fmla="*/ 0 h 954"/>
              <a:gd name="T8" fmla="*/ 196 w 1883"/>
              <a:gd name="T9" fmla="*/ 62 h 954"/>
              <a:gd name="T10" fmla="*/ 235 w 1883"/>
              <a:gd name="T11" fmla="*/ 62 h 954"/>
              <a:gd name="T12" fmla="*/ 235 w 1883"/>
              <a:gd name="T13" fmla="*/ 185 h 954"/>
              <a:gd name="T14" fmla="*/ 314 w 1883"/>
              <a:gd name="T15" fmla="*/ 185 h 954"/>
              <a:gd name="T16" fmla="*/ 314 w 1883"/>
              <a:gd name="T17" fmla="*/ 248 h 954"/>
              <a:gd name="T18" fmla="*/ 392 w 1883"/>
              <a:gd name="T19" fmla="*/ 248 h 954"/>
              <a:gd name="T20" fmla="*/ 392 w 1883"/>
              <a:gd name="T21" fmla="*/ 316 h 954"/>
              <a:gd name="T22" fmla="*/ 471 w 1883"/>
              <a:gd name="T23" fmla="*/ 316 h 954"/>
              <a:gd name="T24" fmla="*/ 471 w 1883"/>
              <a:gd name="T25" fmla="*/ 389 h 954"/>
              <a:gd name="T26" fmla="*/ 707 w 1883"/>
              <a:gd name="T27" fmla="*/ 389 h 954"/>
              <a:gd name="T28" fmla="*/ 707 w 1883"/>
              <a:gd name="T29" fmla="*/ 485 h 954"/>
              <a:gd name="T30" fmla="*/ 746 w 1883"/>
              <a:gd name="T31" fmla="*/ 485 h 954"/>
              <a:gd name="T32" fmla="*/ 746 w 1883"/>
              <a:gd name="T33" fmla="*/ 581 h 954"/>
              <a:gd name="T34" fmla="*/ 981 w 1883"/>
              <a:gd name="T35" fmla="*/ 581 h 954"/>
              <a:gd name="T36" fmla="*/ 981 w 1883"/>
              <a:gd name="T37" fmla="*/ 744 h 954"/>
              <a:gd name="T38" fmla="*/ 1216 w 1883"/>
              <a:gd name="T39" fmla="*/ 744 h 954"/>
              <a:gd name="T40" fmla="*/ 1216 w 1883"/>
              <a:gd name="T41" fmla="*/ 954 h 954"/>
              <a:gd name="T42" fmla="*/ 1883 w 1883"/>
              <a:gd name="T43" fmla="*/ 954 h 954"/>
              <a:gd name="T44" fmla="*/ 1883 w 1883"/>
              <a:gd name="T45" fmla="*/ 954 h 9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</a:cxnLst>
            <a:rect l="0" t="0" r="r" b="b"/>
            <a:pathLst>
              <a:path w="1883" h="954">
                <a:moveTo>
                  <a:pt x="0" y="0"/>
                </a:moveTo>
                <a:lnTo>
                  <a:pt x="79" y="0"/>
                </a:lnTo>
                <a:lnTo>
                  <a:pt x="79" y="0"/>
                </a:lnTo>
                <a:lnTo>
                  <a:pt x="196" y="0"/>
                </a:lnTo>
                <a:lnTo>
                  <a:pt x="196" y="62"/>
                </a:lnTo>
                <a:lnTo>
                  <a:pt x="235" y="62"/>
                </a:lnTo>
                <a:lnTo>
                  <a:pt x="235" y="185"/>
                </a:lnTo>
                <a:lnTo>
                  <a:pt x="314" y="185"/>
                </a:lnTo>
                <a:lnTo>
                  <a:pt x="314" y="248"/>
                </a:lnTo>
                <a:lnTo>
                  <a:pt x="392" y="248"/>
                </a:lnTo>
                <a:lnTo>
                  <a:pt x="392" y="316"/>
                </a:lnTo>
                <a:lnTo>
                  <a:pt x="471" y="316"/>
                </a:lnTo>
                <a:lnTo>
                  <a:pt x="471" y="389"/>
                </a:lnTo>
                <a:lnTo>
                  <a:pt x="707" y="389"/>
                </a:lnTo>
                <a:lnTo>
                  <a:pt x="707" y="485"/>
                </a:lnTo>
                <a:lnTo>
                  <a:pt x="746" y="485"/>
                </a:lnTo>
                <a:lnTo>
                  <a:pt x="746" y="581"/>
                </a:lnTo>
                <a:lnTo>
                  <a:pt x="981" y="581"/>
                </a:lnTo>
                <a:lnTo>
                  <a:pt x="981" y="744"/>
                </a:lnTo>
                <a:lnTo>
                  <a:pt x="1216" y="744"/>
                </a:lnTo>
                <a:lnTo>
                  <a:pt x="1216" y="954"/>
                </a:lnTo>
                <a:lnTo>
                  <a:pt x="1883" y="954"/>
                </a:lnTo>
                <a:lnTo>
                  <a:pt x="1883" y="954"/>
                </a:lnTo>
              </a:path>
            </a:pathLst>
          </a:custGeom>
          <a:noFill/>
          <a:ln w="28575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26" name="Rectangle 108"/>
          <p:cNvSpPr>
            <a:spLocks noChangeArrowheads="1"/>
          </p:cNvSpPr>
          <p:nvPr/>
        </p:nvSpPr>
        <p:spPr bwMode="auto">
          <a:xfrm>
            <a:off x="3900805" y="1222376"/>
            <a:ext cx="4152900" cy="3708400"/>
          </a:xfrm>
          <a:prstGeom prst="rect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" name="CasellaDiTesto 2"/>
          <p:cNvSpPr txBox="1"/>
          <p:nvPr/>
        </p:nvSpPr>
        <p:spPr>
          <a:xfrm>
            <a:off x="1316052" y="529839"/>
            <a:ext cx="10562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Figure S1: Kaplan – Meier survival curves of in-hospital mortality in vitamin D-treated and untreated patients</a:t>
            </a:r>
          </a:p>
        </p:txBody>
      </p:sp>
    </p:spTree>
    <p:extLst>
      <p:ext uri="{BB962C8B-B14F-4D97-AF65-F5344CB8AC3E}">
        <p14:creationId xmlns:p14="http://schemas.microsoft.com/office/powerpoint/2010/main" val="36161516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138895" y="986739"/>
            <a:ext cx="11690430" cy="2540873"/>
            <a:chOff x="659761" y="1620842"/>
            <a:chExt cx="11134837" cy="2678575"/>
          </a:xfrm>
        </p:grpSpPr>
        <p:pic>
          <p:nvPicPr>
            <p:cNvPr id="2" name="Immagine 1"/>
            <p:cNvPicPr>
              <a:picLocks noChangeAspect="1"/>
            </p:cNvPicPr>
            <p:nvPr/>
          </p:nvPicPr>
          <p:blipFill rotWithShape="1">
            <a:blip r:embed="rId2"/>
            <a:srcRect l="14917" t="14297" r="30000" b="46296"/>
            <a:stretch/>
          </p:blipFill>
          <p:spPr>
            <a:xfrm>
              <a:off x="659761" y="1632417"/>
              <a:ext cx="5703210" cy="2667000"/>
            </a:xfrm>
            <a:prstGeom prst="rect">
              <a:avLst/>
            </a:prstGeom>
          </p:spPr>
        </p:pic>
        <p:pic>
          <p:nvPicPr>
            <p:cNvPr id="3" name="Immagine 2"/>
            <p:cNvPicPr>
              <a:picLocks noChangeAspect="1"/>
            </p:cNvPicPr>
            <p:nvPr/>
          </p:nvPicPr>
          <p:blipFill rotWithShape="1">
            <a:blip r:embed="rId2"/>
            <a:srcRect l="18417" t="59036" r="30000" b="2150"/>
            <a:stretch/>
          </p:blipFill>
          <p:spPr>
            <a:xfrm>
              <a:off x="6453770" y="1620842"/>
              <a:ext cx="5340828" cy="2626895"/>
            </a:xfrm>
            <a:prstGeom prst="rect">
              <a:avLst/>
            </a:prstGeom>
          </p:spPr>
        </p:pic>
      </p:grpSp>
      <p:sp>
        <p:nvSpPr>
          <p:cNvPr id="5" name="CasellaDiTesto 4"/>
          <p:cNvSpPr txBox="1"/>
          <p:nvPr/>
        </p:nvSpPr>
        <p:spPr>
          <a:xfrm>
            <a:off x="2609850" y="61540"/>
            <a:ext cx="77152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/>
              <a:t>Figure S2: Kaplan-Meier survival curves showing effect modification by comorbidity burden on </a:t>
            </a:r>
          </a:p>
          <a:p>
            <a:r>
              <a:rPr lang="it-IT" sz="1400" b="1" dirty="0"/>
              <a:t>the effectiveness  of  vitamin D treatment for the combined endpoint (death/ICU transfer)</a:t>
            </a:r>
          </a:p>
        </p:txBody>
      </p:sp>
      <p:sp>
        <p:nvSpPr>
          <p:cNvPr id="6" name="CasellaDiTesto 5"/>
          <p:cNvSpPr txBox="1"/>
          <p:nvPr/>
        </p:nvSpPr>
        <p:spPr>
          <a:xfrm>
            <a:off x="1302378" y="706079"/>
            <a:ext cx="15103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err="1"/>
              <a:t>Comorbidity</a:t>
            </a:r>
            <a:r>
              <a:rPr lang="it-IT" sz="1100" b="1" dirty="0"/>
              <a:t> </a:t>
            </a:r>
            <a:r>
              <a:rPr lang="it-IT" sz="1100" b="1" dirty="0" err="1"/>
              <a:t>burden</a:t>
            </a:r>
            <a:r>
              <a:rPr lang="it-IT" sz="1100" b="1" dirty="0"/>
              <a:t>=0</a:t>
            </a:r>
          </a:p>
        </p:txBody>
      </p:sp>
      <p:sp>
        <p:nvSpPr>
          <p:cNvPr id="7" name="CasellaDiTesto 6"/>
          <p:cNvSpPr txBox="1"/>
          <p:nvPr/>
        </p:nvSpPr>
        <p:spPr>
          <a:xfrm>
            <a:off x="4329691" y="706079"/>
            <a:ext cx="15103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err="1"/>
              <a:t>Comorbidity</a:t>
            </a:r>
            <a:r>
              <a:rPr lang="it-IT" sz="1100" b="1" dirty="0"/>
              <a:t> </a:t>
            </a:r>
            <a:r>
              <a:rPr lang="it-IT" sz="1100" b="1" dirty="0" err="1"/>
              <a:t>burden</a:t>
            </a:r>
            <a:r>
              <a:rPr lang="it-IT" sz="1100" b="1" dirty="0"/>
              <a:t>=1</a:t>
            </a:r>
          </a:p>
        </p:txBody>
      </p:sp>
      <p:sp>
        <p:nvSpPr>
          <p:cNvPr id="8" name="CasellaDiTesto 7"/>
          <p:cNvSpPr txBox="1"/>
          <p:nvPr/>
        </p:nvSpPr>
        <p:spPr>
          <a:xfrm>
            <a:off x="7092777" y="706079"/>
            <a:ext cx="15103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err="1"/>
              <a:t>Comorbidity</a:t>
            </a:r>
            <a:r>
              <a:rPr lang="it-IT" sz="1100" b="1" dirty="0"/>
              <a:t> </a:t>
            </a:r>
            <a:r>
              <a:rPr lang="it-IT" sz="1100" b="1" dirty="0" err="1"/>
              <a:t>burden</a:t>
            </a:r>
            <a:r>
              <a:rPr lang="it-IT" sz="1100" b="1" dirty="0"/>
              <a:t>=2</a:t>
            </a:r>
          </a:p>
        </p:txBody>
      </p:sp>
      <p:sp>
        <p:nvSpPr>
          <p:cNvPr id="9" name="CasellaDiTesto 8"/>
          <p:cNvSpPr txBox="1"/>
          <p:nvPr/>
        </p:nvSpPr>
        <p:spPr>
          <a:xfrm>
            <a:off x="10021805" y="706079"/>
            <a:ext cx="15103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err="1"/>
              <a:t>Comorbidity</a:t>
            </a:r>
            <a:r>
              <a:rPr lang="it-IT" sz="1100" b="1" dirty="0"/>
              <a:t> </a:t>
            </a:r>
            <a:r>
              <a:rPr lang="it-IT" sz="1100" b="1" dirty="0" err="1"/>
              <a:t>burden</a:t>
            </a:r>
            <a:r>
              <a:rPr lang="it-IT" sz="1100" b="1" u="sng" dirty="0"/>
              <a:t>&gt;</a:t>
            </a:r>
            <a:r>
              <a:rPr lang="it-IT" sz="1100" b="1" dirty="0"/>
              <a:t>3</a:t>
            </a:r>
          </a:p>
        </p:txBody>
      </p:sp>
      <p:pic>
        <p:nvPicPr>
          <p:cNvPr id="14" name="Immagine 13"/>
          <p:cNvPicPr>
            <a:picLocks noChangeAspect="1"/>
          </p:cNvPicPr>
          <p:nvPr/>
        </p:nvPicPr>
        <p:blipFill rotWithShape="1">
          <a:blip r:embed="rId3"/>
          <a:srcRect l="28250" t="37111" r="27084" b="23778"/>
          <a:stretch/>
        </p:blipFill>
        <p:spPr>
          <a:xfrm>
            <a:off x="2878750" y="3663999"/>
            <a:ext cx="6321911" cy="31137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62471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5</TotalTime>
  <Words>88</Words>
  <Application>Microsoft Office PowerPoint</Application>
  <PresentationFormat>Widescreen</PresentationFormat>
  <Paragraphs>1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ccount Microsoft</dc:creator>
  <cp:lastModifiedBy>Colin Egan</cp:lastModifiedBy>
  <cp:revision>38</cp:revision>
  <dcterms:created xsi:type="dcterms:W3CDTF">2021-01-05T18:22:36Z</dcterms:created>
  <dcterms:modified xsi:type="dcterms:W3CDTF">2021-01-06T18:47:49Z</dcterms:modified>
</cp:coreProperties>
</file>